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61D02-6D78-4D62-B806-12AEFEAE38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2539E-0786-4E21-A5EC-EB230B176E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0EC5F-61C2-41E9-9CC6-5535B958E1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4C98B-2A37-4EEA-A35B-90CC8808B0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5222B-8B11-4170-B818-3B3F1E0008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35080-68E1-4A58-A4B1-5EAA9CF8A5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CC7EA-2D25-475E-A855-B03623D057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F0603-0970-4DD8-82D3-067FB2DD36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D64E2-1841-4275-BC1A-61B05BFD87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38C4F-BD21-42B2-B393-A558A5594A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DAA1C-848D-4781-9D22-263B8826D6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DA4BA1-2255-447C-A6B8-6095C79113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10EEE-8B65-40A1-9792-A48E42109A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53503" b="0"/>
          <a:stretch/>
        </p:blipFill>
        <p:spPr>
          <a:xfrm>
            <a:off x="1752480" y="380880"/>
            <a:ext cx="3092400" cy="6640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09480" y="7161480"/>
            <a:ext cx="59436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eproducibility of ChIP-chip experiments.  Normalized log ratios (immonuprecipated DNA over total input DNA) of the biological replicate experiments (0 hrs untreated or 3 hrs TGF-β1-treated) are plotted as smooth scatter plots. Binding ratios for 150 significant genes are indicated by red dots. The overall correlation coefficient of each plot is also show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19T14:31:36Z</dcterms:created>
  <dc:creator>Huaxia Qin</dc:creator>
  <dc:description/>
  <dc:language>en-US</dc:language>
  <cp:lastModifiedBy>Davu01</cp:lastModifiedBy>
  <dcterms:modified xsi:type="dcterms:W3CDTF">2008-12-11T01:53:51Z</dcterms:modified>
  <cp:revision>30</cp:revision>
  <dc:subject/>
  <dc:title>Slide 1</dc:title>
</cp:coreProperties>
</file>